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15306F-2D72-46C1-A0D6-BA5080AD94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542499-02B4-4636-BDF4-B78D1AC205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1D7A25-9CC7-4545-8C66-83DF7C3081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A239F0-F729-4B3C-BBBF-8101B13D9A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D41437-63A6-4FD5-8C89-030375C84A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42927B-EE34-4AF6-B512-7C57F677D7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6D55FC-7075-4A3F-AAFB-BBA7003B1E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8005AC-39DB-4E3E-B658-126B90F450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549F5C-A6A7-4B41-AA33-24E62F1BDD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27D73D-C495-47C9-872F-8287BC27FC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E1F1DC-F596-4AA3-8A9C-F5F7969782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07B847-6837-4693-A4A0-EB90DDD671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4C1EE21-07A6-420F-A0DB-87628158B5F1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71680" y="2998800"/>
            <a:ext cx="6948360" cy="755640"/>
          </a:xfrm>
          <a:prstGeom prst="rect">
            <a:avLst/>
          </a:prstGeom>
          <a:solidFill>
            <a:srgbClr val="e2e3e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468800" y="954000"/>
            <a:ext cx="1607760" cy="5022000"/>
            <a:chOff x="1468800" y="954000"/>
            <a:chExt cx="1607760" cy="5022000"/>
          </a:xfrm>
        </p:grpSpPr>
        <p:sp>
          <p:nvSpPr>
            <p:cNvPr id="43" name=""/>
            <p:cNvSpPr/>
            <p:nvPr/>
          </p:nvSpPr>
          <p:spPr>
            <a:xfrm>
              <a:off x="1468800" y="954000"/>
              <a:ext cx="1552320" cy="5022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</a:t>
              </a:r>
              <a:r>
                <a:rPr b="1" lang="fr-FR" sz="1200" spc="-1" strike="noStrike">
                  <a:solidFill>
                    <a:srgbClr val="000000"/>
                  </a:solidFill>
                  <a:latin typeface="Courier New"/>
                </a:rPr>
                <a:t>tRNA-Met(CAU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C +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C +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G +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30  C + G  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A + 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  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C +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U +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34  </a:t>
              </a:r>
              <a:r>
                <a:rPr b="1" lang="fr-FR" sz="1200" spc="-1" strike="noStrike">
                  <a:solidFill>
                    <a:srgbClr val="000000"/>
                  </a:solidFill>
                  <a:latin typeface="Courier New"/>
                </a:rPr>
                <a:t>C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+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1" lang="fr-FR" sz="1200" spc="-1" strike="noStrike">
                  <a:solidFill>
                    <a:srgbClr val="000000"/>
                  </a:solidFill>
                  <a:latin typeface="Courier New"/>
                </a:rPr>
                <a:t>A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+ 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</a:t>
              </a:r>
              <a:r>
                <a:rPr b="1" lang="fr-FR" sz="1200" spc="-1" strike="noStrike">
                  <a:solidFill>
                    <a:srgbClr val="000000"/>
                  </a:solidFill>
                  <a:latin typeface="Courier New"/>
                </a:rPr>
                <a:t>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g +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g +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u +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u    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u    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c    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.     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.     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.     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152800" y="2508120"/>
              <a:ext cx="0" cy="457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 flipV="1">
              <a:off x="2846520" y="2350800"/>
              <a:ext cx="230040" cy="2300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headEnd len="med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517840" y="3780000"/>
              <a:ext cx="0" cy="457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flipV="1">
              <a:off x="1619280" y="4111560"/>
              <a:ext cx="230400" cy="2304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8" name=""/>
          <p:cNvGrpSpPr/>
          <p:nvPr/>
        </p:nvGrpSpPr>
        <p:grpSpPr>
          <a:xfrm>
            <a:off x="3751200" y="954000"/>
            <a:ext cx="1600200" cy="5752080"/>
            <a:chOff x="3751200" y="954000"/>
            <a:chExt cx="1600200" cy="5752080"/>
          </a:xfrm>
        </p:grpSpPr>
        <p:sp>
          <p:nvSpPr>
            <p:cNvPr id="49" name=""/>
            <p:cNvSpPr/>
            <p:nvPr/>
          </p:nvSpPr>
          <p:spPr>
            <a:xfrm>
              <a:off x="3751200" y="954000"/>
              <a:ext cx="1552320" cy="5752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</a:t>
              </a:r>
              <a:r>
                <a:rPr b="1" lang="fr-FR" sz="1200" spc="-1" strike="noStrike">
                  <a:solidFill>
                    <a:srgbClr val="000000"/>
                  </a:solidFill>
                  <a:latin typeface="Courier New"/>
                </a:rPr>
                <a:t>tRNA-Gln(UUG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G +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C +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G +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30  G + C  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C +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  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C +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U +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34 </a:t>
              </a:r>
              <a:r>
                <a:rPr b="1" lang="fr-FR" sz="1200" spc="-1" strike="noStrike">
                  <a:solidFill>
                    <a:srgbClr val="000000"/>
                  </a:solidFill>
                  <a:latin typeface="Courier New"/>
                </a:rPr>
                <a:t>U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+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1" lang="fr-FR" sz="1200" spc="-1" strike="noStrike">
                  <a:solidFill>
                    <a:srgbClr val="000000"/>
                  </a:solidFill>
                  <a:latin typeface="Courier New"/>
                </a:rPr>
                <a:t>U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+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</a:t>
              </a:r>
              <a:r>
                <a:rPr b="1" lang="fr-FR" sz="1200" spc="-1" strike="noStrike">
                  <a:solidFill>
                    <a:srgbClr val="000000"/>
                  </a:solidFill>
                  <a:latin typeface="Courier New"/>
                </a:rPr>
                <a:t>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u +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u +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g +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g +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u +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a + 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c +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g +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g    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u     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u     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c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435560" y="2508120"/>
              <a:ext cx="0" cy="457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flipV="1">
              <a:off x="5121360" y="2350800"/>
              <a:ext cx="230040" cy="2300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headEnd len="med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800600" y="3780000"/>
              <a:ext cx="0" cy="457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flipV="1">
              <a:off x="3905280" y="4111560"/>
              <a:ext cx="230040" cy="2304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4" name=""/>
          <p:cNvGrpSpPr/>
          <p:nvPr/>
        </p:nvGrpSpPr>
        <p:grpSpPr>
          <a:xfrm>
            <a:off x="6027840" y="954000"/>
            <a:ext cx="1592280" cy="5387040"/>
            <a:chOff x="6027840" y="954000"/>
            <a:chExt cx="1592280" cy="5387040"/>
          </a:xfrm>
        </p:grpSpPr>
        <p:sp>
          <p:nvSpPr>
            <p:cNvPr id="55" name=""/>
            <p:cNvSpPr/>
            <p:nvPr/>
          </p:nvSpPr>
          <p:spPr>
            <a:xfrm>
              <a:off x="6027840" y="954000"/>
              <a:ext cx="1552320" cy="5387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</a:t>
              </a:r>
              <a:r>
                <a:rPr b="1" lang="fr-FR" sz="1200" spc="-1" strike="noStrike">
                  <a:solidFill>
                    <a:srgbClr val="000000"/>
                  </a:solidFill>
                  <a:latin typeface="Courier New"/>
                </a:rPr>
                <a:t>tRNA-Trp(CC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A + 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C +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U +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30  G + C  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A + 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  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C +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U +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34 </a:t>
              </a:r>
              <a:r>
                <a:rPr b="1" lang="fr-FR" sz="1200" spc="-1" strike="noStrike">
                  <a:solidFill>
                    <a:srgbClr val="000000"/>
                  </a:solidFill>
                  <a:latin typeface="Courier New"/>
                </a:rPr>
                <a:t>C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+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1" lang="fr-FR" sz="1200" spc="-1" strike="noStrike">
                  <a:solidFill>
                    <a:srgbClr val="000000"/>
                  </a:solidFill>
                  <a:latin typeface="Courier New"/>
                </a:rPr>
                <a:t>C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+ 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</a:t>
              </a:r>
              <a:r>
                <a:rPr b="1" lang="fr-FR" sz="1200" spc="-1" strike="noStrike">
                  <a:solidFill>
                    <a:srgbClr val="000000"/>
                  </a:solidFill>
                  <a:latin typeface="Courier New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g +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g +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c    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u    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u    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.     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.     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</a:t>
              </a: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.     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ourier New"/>
                </a:rPr>
                <a:t>     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6703920" y="2507760"/>
              <a:ext cx="0" cy="4568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flipV="1">
              <a:off x="7389720" y="2350800"/>
              <a:ext cx="230400" cy="2296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headEnd len="med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7068960" y="3779640"/>
              <a:ext cx="0" cy="4568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flipV="1">
              <a:off x="6173640" y="4110840"/>
              <a:ext cx="230400" cy="2300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0" name=""/>
          <p:cNvSpPr/>
          <p:nvPr/>
        </p:nvSpPr>
        <p:spPr>
          <a:xfrm>
            <a:off x="814320" y="180180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802080" y="25369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802080" y="32050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802080" y="38307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813960" y="4403880"/>
            <a:ext cx="38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h’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772920" y="333360"/>
            <a:ext cx="75171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The hBHBh’ structure of the introns in pre-tRNA-Met (CAU), pre-tRNA-Gln (UUG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and pre-tRNA-Trp (CCA) in </a:t>
            </a:r>
            <a:r>
              <a:rPr b="1" i="1" lang="en-US" sz="1600" spc="-1" strike="noStrike">
                <a:solidFill>
                  <a:srgbClr val="000000"/>
                </a:solidFill>
                <a:latin typeface="Times New Roman"/>
              </a:rPr>
              <a:t>Haloferax volcanii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14T10:02:56Z</dcterms:created>
  <dc:creator>Christian Marck</dc:creator>
  <dc:description/>
  <dc:language>en-US</dc:language>
  <cp:lastModifiedBy>Valerie de Crecy</cp:lastModifiedBy>
  <cp:lastPrinted>2008-04-14T11:47:00Z</cp:lastPrinted>
  <dcterms:modified xsi:type="dcterms:W3CDTF">2008-09-29T14:30:10Z</dcterms:modified>
  <cp:revision>13</cp:revision>
  <dc:subject/>
  <dc:title>Présentation PowerPoint</dc:title>
</cp:coreProperties>
</file>